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9" r:id="rId2"/>
    <p:sldId id="279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  <a:srgbClr val="FFFFFF"/>
    <a:srgbClr val="A6A6A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816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390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21338;&#22763;\&#21338;&#22763;&#35770;&#25991;\&#35770;&#25991;&#24635;&#32467;&#26448;&#26009;\&#22522;&#22240;&#34920;&#36798;&#25968;&#25454;&#24211;&#20449;&#24687;&#20998;&#26512;\heat%20map\W1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0" vertOverflow="ellipsis" vert="horz" wrap="square" anchor="ctr" anchorCtr="1"/>
          <a:lstStyle/>
          <a:p>
            <a:pPr>
              <a:defRPr lang="zh-CN" sz="108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b="0"/>
              <a:t>TaWRIL1</a:t>
            </a:r>
            <a:endParaRPr lang="zh-CN" b="0"/>
          </a:p>
        </c:rich>
      </c:tx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B$12</c:f>
              <c:strCache>
                <c:ptCount val="1"/>
                <c:pt idx="0">
                  <c:v>TraesCS5A02G221600</c:v>
                </c:pt>
              </c:strCache>
            </c:strRef>
          </c:tx>
          <c:cat>
            <c:strRef>
              <c:f>Sheet1!$C$11:$I$11</c:f>
              <c:strCache>
                <c:ptCount val="7"/>
                <c:pt idx="0">
                  <c:v>Two Cell Embryo</c:v>
                </c:pt>
                <c:pt idx="1">
                  <c:v>Pre-Embryo</c:v>
                </c:pt>
                <c:pt idx="2">
                  <c:v>Transition Embryo</c:v>
                </c:pt>
                <c:pt idx="3">
                  <c:v>Leaf Early Embryo</c:v>
                </c:pt>
                <c:pt idx="4">
                  <c:v>Leaf Middle Embryo</c:v>
                </c:pt>
                <c:pt idx="5">
                  <c:v>Leaf Late Endosperm</c:v>
                </c:pt>
                <c:pt idx="6">
                  <c:v>Mature Embryo</c:v>
                </c:pt>
              </c:strCache>
            </c:strRef>
          </c:cat>
          <c:val>
            <c:numRef>
              <c:f>Sheet1!$C$12:$I$12</c:f>
              <c:numCache>
                <c:formatCode>0.00_ </c:formatCode>
                <c:ptCount val="7"/>
                <c:pt idx="0">
                  <c:v>0</c:v>
                </c:pt>
                <c:pt idx="1">
                  <c:v>0.3</c:v>
                </c:pt>
                <c:pt idx="2">
                  <c:v>0.7</c:v>
                </c:pt>
                <c:pt idx="3">
                  <c:v>0.3</c:v>
                </c:pt>
                <c:pt idx="4">
                  <c:v>0</c:v>
                </c:pt>
                <c:pt idx="5">
                  <c:v>1.9</c:v>
                </c:pt>
                <c:pt idx="6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E75-4CE5-BD23-9B5E1E18E145}"/>
            </c:ext>
          </c:extLst>
        </c:ser>
        <c:ser>
          <c:idx val="1"/>
          <c:order val="1"/>
          <c:tx>
            <c:strRef>
              <c:f>Sheet1!$B$13</c:f>
              <c:strCache>
                <c:ptCount val="1"/>
                <c:pt idx="0">
                  <c:v>TraesCS5B02G220400</c:v>
                </c:pt>
              </c:strCache>
            </c:strRef>
          </c:tx>
          <c:cat>
            <c:strRef>
              <c:f>Sheet1!$C$11:$I$11</c:f>
              <c:strCache>
                <c:ptCount val="7"/>
                <c:pt idx="0">
                  <c:v>Two Cell Embryo</c:v>
                </c:pt>
                <c:pt idx="1">
                  <c:v>Pre-Embryo</c:v>
                </c:pt>
                <c:pt idx="2">
                  <c:v>Transition Embryo</c:v>
                </c:pt>
                <c:pt idx="3">
                  <c:v>Leaf Early Embryo</c:v>
                </c:pt>
                <c:pt idx="4">
                  <c:v>Leaf Middle Embryo</c:v>
                </c:pt>
                <c:pt idx="5">
                  <c:v>Leaf Late Endosperm</c:v>
                </c:pt>
                <c:pt idx="6">
                  <c:v>Mature Embryo</c:v>
                </c:pt>
              </c:strCache>
            </c:strRef>
          </c:cat>
          <c:val>
            <c:numRef>
              <c:f>Sheet1!$C$13:$I$13</c:f>
              <c:numCache>
                <c:formatCode>0.00_ </c:formatCode>
                <c:ptCount val="7"/>
                <c:pt idx="0">
                  <c:v>12.6</c:v>
                </c:pt>
                <c:pt idx="1">
                  <c:v>5.2</c:v>
                </c:pt>
                <c:pt idx="2">
                  <c:v>4.3</c:v>
                </c:pt>
                <c:pt idx="3">
                  <c:v>3.3</c:v>
                </c:pt>
                <c:pt idx="4">
                  <c:v>4</c:v>
                </c:pt>
                <c:pt idx="5">
                  <c:v>15.3</c:v>
                </c:pt>
                <c:pt idx="6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E75-4CE5-BD23-9B5E1E18E145}"/>
            </c:ext>
          </c:extLst>
        </c:ser>
        <c:ser>
          <c:idx val="2"/>
          <c:order val="2"/>
          <c:tx>
            <c:strRef>
              <c:f>Sheet1!$B$14</c:f>
              <c:strCache>
                <c:ptCount val="1"/>
                <c:pt idx="0">
                  <c:v>TraesCS5D02G229400</c:v>
                </c:pt>
              </c:strCache>
            </c:strRef>
          </c:tx>
          <c:cat>
            <c:strRef>
              <c:f>Sheet1!$C$11:$I$11</c:f>
              <c:strCache>
                <c:ptCount val="7"/>
                <c:pt idx="0">
                  <c:v>Two Cell Embryo</c:v>
                </c:pt>
                <c:pt idx="1">
                  <c:v>Pre-Embryo</c:v>
                </c:pt>
                <c:pt idx="2">
                  <c:v>Transition Embryo</c:v>
                </c:pt>
                <c:pt idx="3">
                  <c:v>Leaf Early Embryo</c:v>
                </c:pt>
                <c:pt idx="4">
                  <c:v>Leaf Middle Embryo</c:v>
                </c:pt>
                <c:pt idx="5">
                  <c:v>Leaf Late Endosperm</c:v>
                </c:pt>
                <c:pt idx="6">
                  <c:v>Mature Embryo</c:v>
                </c:pt>
              </c:strCache>
            </c:strRef>
          </c:cat>
          <c:val>
            <c:numRef>
              <c:f>Sheet1!$C$14:$I$14</c:f>
              <c:numCache>
                <c:formatCode>0.00_ </c:formatCode>
                <c:ptCount val="7"/>
                <c:pt idx="0">
                  <c:v>0.6</c:v>
                </c:pt>
                <c:pt idx="1">
                  <c:v>3.7</c:v>
                </c:pt>
                <c:pt idx="2">
                  <c:v>1.5</c:v>
                </c:pt>
                <c:pt idx="3">
                  <c:v>0.2</c:v>
                </c:pt>
                <c:pt idx="4">
                  <c:v>0.2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EE75-4CE5-BD23-9B5E1E18E14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2553472"/>
        <c:axId val="102555008"/>
      </c:lineChart>
      <c:catAx>
        <c:axId val="1025534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2555008"/>
        <c:crosses val="autoZero"/>
        <c:auto val="1"/>
        <c:lblAlgn val="ctr"/>
        <c:lblOffset val="100"/>
        <c:noMultiLvlLbl val="0"/>
      </c:catAx>
      <c:valAx>
        <c:axId val="1025550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tint val="75000"/>
                </a:schemeClr>
              </a:solidFill>
              <a:prstDash val="solid"/>
              <a:round/>
            </a:ln>
          </c:spPr>
        </c:majorGridlines>
        <c:title>
          <c:tx>
            <c:rich>
              <a:bodyPr rot="-5400000" spcFirstLastPara="0" vertOverflow="ellipsis" vert="horz" wrap="square" anchor="ctr" anchorCtr="1"/>
              <a:lstStyle/>
              <a:p>
                <a:pPr>
                  <a:defRPr lang="zh-CN" sz="9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TPM</a:t>
                </a:r>
                <a:endParaRPr lang="zh-CN" dirty="0"/>
              </a:p>
            </c:rich>
          </c:tx>
          <c:layout>
            <c:manualLayout>
              <c:xMode val="edge"/>
              <c:yMode val="edge"/>
              <c:x val="3.0418883485442302E-2"/>
              <c:y val="0.348354765006892"/>
            </c:manualLayout>
          </c:layout>
          <c:overlay val="0"/>
        </c:title>
        <c:numFmt formatCode="0.00_ " sourceLinked="1"/>
        <c:majorTickMark val="none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255347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31736687414023"/>
          <c:y val="0.18063610632655899"/>
          <c:w val="0.368263312585977"/>
          <c:h val="0.48955333442388999"/>
        </c:manualLayout>
      </c:layout>
      <c:overlay val="0"/>
      <c:txPr>
        <a:bodyPr rot="0" spcFirstLastPara="0" vertOverflow="ellipsis" vert="horz" wrap="square" anchor="ctr" anchorCtr="1"/>
        <a:lstStyle/>
        <a:p>
          <a:pPr>
            <a:defRPr lang="zh-CN"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>
      <a:noFill/>
    </a:ln>
  </c:spPr>
  <c:txPr>
    <a:bodyPr/>
    <a:lstStyle/>
    <a:p>
      <a:pPr>
        <a:defRPr lang="zh-CN" sz="90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zh-CN" sz="1080" b="0" i="0" u="none" strike="noStrike" kern="1200" spc="0" baseline="0">
                <a:solidFill>
                  <a:schemeClr val="tx1">
                    <a:lumMod val="95000"/>
                    <a:lumOff val="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TaWRIL2</a:t>
            </a:r>
            <a:endParaRPr lang="zh-CN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TraesCS5A02G141700!$A$28</c:f>
              <c:strCache>
                <c:ptCount val="1"/>
                <c:pt idx="0">
                  <c:v>TraesCS5A02G141700</c:v>
                </c:pt>
              </c:strCache>
            </c:strRef>
          </c:tx>
          <c:spPr>
            <a:ln w="28575" cap="rnd" cmpd="sng" algn="ctr">
              <a:solidFill>
                <a:schemeClr val="accent1"/>
              </a:solidFill>
              <a:prstDash val="solid"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 cap="flat" cmpd="sng" algn="ctr">
                <a:solidFill>
                  <a:schemeClr val="accent1"/>
                </a:solidFill>
                <a:prstDash val="solid"/>
                <a:round/>
              </a:ln>
              <a:effectLst/>
            </c:spPr>
          </c:marker>
          <c:cat>
            <c:strRef>
              <c:f>TraesCS5A02G141700!$B$27:$J$27</c:f>
              <c:strCache>
                <c:ptCount val="7"/>
                <c:pt idx="0">
                  <c:v>Two Cell Embryo</c:v>
                </c:pt>
                <c:pt idx="1">
                  <c:v>Pre-Embryo</c:v>
                </c:pt>
                <c:pt idx="2">
                  <c:v>Transition Embryo</c:v>
                </c:pt>
                <c:pt idx="3">
                  <c:v>Leaf Early Embryo</c:v>
                </c:pt>
                <c:pt idx="4">
                  <c:v>Leaf Middle Embryo</c:v>
                </c:pt>
                <c:pt idx="5">
                  <c:v>Leaf Late Embryo</c:v>
                </c:pt>
                <c:pt idx="6">
                  <c:v>Mature Embryo</c:v>
                </c:pt>
              </c:strCache>
            </c:strRef>
          </c:cat>
          <c:val>
            <c:numRef>
              <c:f>TraesCS5A02G141700!$B$28:$J$28</c:f>
              <c:numCache>
                <c:formatCode>General</c:formatCode>
                <c:ptCount val="7"/>
                <c:pt idx="0">
                  <c:v>150.1</c:v>
                </c:pt>
                <c:pt idx="1">
                  <c:v>75</c:v>
                </c:pt>
                <c:pt idx="2">
                  <c:v>48.2</c:v>
                </c:pt>
                <c:pt idx="3">
                  <c:v>121.5</c:v>
                </c:pt>
                <c:pt idx="4">
                  <c:v>372.9</c:v>
                </c:pt>
                <c:pt idx="5">
                  <c:v>123.8</c:v>
                </c:pt>
                <c:pt idx="6">
                  <c:v>21.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9D8-4B02-AAA5-6664402089D0}"/>
            </c:ext>
          </c:extLst>
        </c:ser>
        <c:ser>
          <c:idx val="1"/>
          <c:order val="1"/>
          <c:tx>
            <c:strRef>
              <c:f>TraesCS5A02G141700!$A$29</c:f>
              <c:strCache>
                <c:ptCount val="1"/>
                <c:pt idx="0">
                  <c:v>TraesCS5D02G150500</c:v>
                </c:pt>
              </c:strCache>
            </c:strRef>
          </c:tx>
          <c:spPr>
            <a:ln w="28575" cap="flat" cmpd="sng" algn="ctr">
              <a:solidFill>
                <a:schemeClr val="accent2"/>
              </a:solidFill>
              <a:prstDash val="solid"/>
              <a:bevel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 cap="flat" cmpd="sng" algn="ctr">
                <a:solidFill>
                  <a:schemeClr val="accent2"/>
                </a:solidFill>
                <a:prstDash val="solid"/>
                <a:round/>
              </a:ln>
              <a:effectLst/>
            </c:spPr>
          </c:marker>
          <c:cat>
            <c:strRef>
              <c:f>TraesCS5A02G141700!$B$27:$J$27</c:f>
              <c:strCache>
                <c:ptCount val="7"/>
                <c:pt idx="0">
                  <c:v>Two Cell Embryo</c:v>
                </c:pt>
                <c:pt idx="1">
                  <c:v>Pre-Embryo</c:v>
                </c:pt>
                <c:pt idx="2">
                  <c:v>Transition Embryo</c:v>
                </c:pt>
                <c:pt idx="3">
                  <c:v>Leaf Early Embryo</c:v>
                </c:pt>
                <c:pt idx="4">
                  <c:v>Leaf Middle Embryo</c:v>
                </c:pt>
                <c:pt idx="5">
                  <c:v>Leaf Late Embryo</c:v>
                </c:pt>
                <c:pt idx="6">
                  <c:v>Mature Embryo</c:v>
                </c:pt>
              </c:strCache>
            </c:strRef>
          </c:cat>
          <c:val>
            <c:numRef>
              <c:f>TraesCS5A02G141700!$B$29:$J$29</c:f>
              <c:numCache>
                <c:formatCode>General</c:formatCode>
                <c:ptCount val="7"/>
                <c:pt idx="0">
                  <c:v>23.2</c:v>
                </c:pt>
                <c:pt idx="1">
                  <c:v>20.6</c:v>
                </c:pt>
                <c:pt idx="2">
                  <c:v>17.5</c:v>
                </c:pt>
                <c:pt idx="3">
                  <c:v>31.7</c:v>
                </c:pt>
                <c:pt idx="4">
                  <c:v>88.1</c:v>
                </c:pt>
                <c:pt idx="5">
                  <c:v>61</c:v>
                </c:pt>
                <c:pt idx="6">
                  <c:v>5.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9D8-4B02-AAA5-6664402089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5493632"/>
        <c:axId val="105495552"/>
      </c:lineChart>
      <c:catAx>
        <c:axId val="1054936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5495552"/>
        <c:crosses val="autoZero"/>
        <c:auto val="1"/>
        <c:lblAlgn val="ctr"/>
        <c:lblOffset val="100"/>
        <c:noMultiLvlLbl val="0"/>
      </c:catAx>
      <c:valAx>
        <c:axId val="1054955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prstDash val="solid"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zh-CN" sz="900" b="0" i="0" u="none" strike="noStrike" kern="1200" baseline="0">
                    <a:solidFill>
                      <a:schemeClr val="tx1">
                        <a:lumMod val="95000"/>
                        <a:lumOff val="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TPM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noFill/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95000"/>
                    <a:lumOff val="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054936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11516354651648"/>
          <c:y val="0.240705249697794"/>
          <c:w val="0.38157726943104803"/>
          <c:h val="0.2676081319030300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zh-CN" sz="900" b="0" i="0" u="none" strike="noStrike" kern="1200" baseline="0">
              <a:solidFill>
                <a:schemeClr val="tx1">
                  <a:lumMod val="95000"/>
                  <a:lumOff val="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bevel/>
    </a:ln>
    <a:effectLst/>
  </c:spPr>
  <c:txPr>
    <a:bodyPr/>
    <a:lstStyle/>
    <a:p>
      <a:pPr>
        <a:defRPr lang="zh-CN" sz="900">
          <a:solidFill>
            <a:schemeClr val="tx1">
              <a:lumMod val="95000"/>
              <a:lumOff val="5000"/>
            </a:schemeClr>
          </a:solidFill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8E5A7-344B-460F-A40A-3581CF93578A}" type="datetimeFigureOut">
              <a:rPr lang="zh-CN" altLang="en-US" smtClean="0"/>
              <a:t>2022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0BA11-B7A6-408D-B6C7-DF70EA8DE41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8E5A7-344B-460F-A40A-3581CF93578A}" type="datetimeFigureOut">
              <a:rPr lang="zh-CN" altLang="en-US" smtClean="0"/>
              <a:t>2022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0BA11-B7A6-408D-B6C7-DF70EA8DE41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 hasCustomPrompt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8E5A7-344B-460F-A40A-3581CF93578A}" type="datetimeFigureOut">
              <a:rPr lang="zh-CN" altLang="en-US" smtClean="0"/>
              <a:t>2022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0BA11-B7A6-408D-B6C7-DF70EA8DE41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8E5A7-344B-460F-A40A-3581CF93578A}" type="datetimeFigureOut">
              <a:rPr lang="zh-CN" altLang="en-US" smtClean="0"/>
              <a:t>2022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0BA11-B7A6-408D-B6C7-DF70EA8DE41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8E5A7-344B-460F-A40A-3581CF93578A}" type="datetimeFigureOut">
              <a:rPr lang="zh-CN" altLang="en-US" smtClean="0"/>
              <a:t>2022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0BA11-B7A6-408D-B6C7-DF70EA8DE41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 hasCustomPrompt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 hasCustomPrompt="1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8E5A7-344B-460F-A40A-3581CF93578A}" type="datetimeFigureOut">
              <a:rPr lang="zh-CN" altLang="en-US" smtClean="0"/>
              <a:t>2022/5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0BA11-B7A6-408D-B6C7-DF70EA8DE41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 hasCustomPrompt="1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 hasCustomPrompt="1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8E5A7-344B-460F-A40A-3581CF93578A}" type="datetimeFigureOut">
              <a:rPr lang="zh-CN" altLang="en-US" smtClean="0"/>
              <a:t>2022/5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0BA11-B7A6-408D-B6C7-DF70EA8DE41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8E5A7-344B-460F-A40A-3581CF93578A}" type="datetimeFigureOut">
              <a:rPr lang="zh-CN" altLang="en-US" smtClean="0"/>
              <a:t>2022/5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0BA11-B7A6-408D-B6C7-DF70EA8DE41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8E5A7-344B-460F-A40A-3581CF93578A}" type="datetimeFigureOut">
              <a:rPr lang="zh-CN" altLang="en-US" smtClean="0"/>
              <a:t>2022/5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0BA11-B7A6-408D-B6C7-DF70EA8DE41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 hasCustomPrompt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8E5A7-344B-460F-A40A-3581CF93578A}" type="datetimeFigureOut">
              <a:rPr lang="zh-CN" altLang="en-US" smtClean="0"/>
              <a:t>2022/5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0BA11-B7A6-408D-B6C7-DF70EA8DE41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C8E5A7-344B-460F-A40A-3581CF93578A}" type="datetimeFigureOut">
              <a:rPr lang="zh-CN" altLang="en-US" smtClean="0"/>
              <a:t>2022/5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0BA11-B7A6-408D-B6C7-DF70EA8DE41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C8E5A7-344B-460F-A40A-3581CF93578A}" type="datetimeFigureOut">
              <a:rPr lang="zh-CN" altLang="en-US" smtClean="0"/>
              <a:t>2022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A0BA11-B7A6-408D-B6C7-DF70EA8DE415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image" Target="../media/image6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6936" y="646330"/>
            <a:ext cx="5658500" cy="4886771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35436" y="646330"/>
            <a:ext cx="6120677" cy="4816922"/>
          </a:xfrm>
          <a:prstGeom prst="rect">
            <a:avLst/>
          </a:prstGeom>
        </p:spPr>
      </p:pic>
      <p:sp>
        <p:nvSpPr>
          <p:cNvPr id="7" name="文本框 1"/>
          <p:cNvSpPr txBox="1"/>
          <p:nvPr/>
        </p:nvSpPr>
        <p:spPr>
          <a:xfrm>
            <a:off x="2256038" y="5880878"/>
            <a:ext cx="7358795" cy="646331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igure S1. T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he deduced amino acid sequence alignment of TaWRI1Ls of Chinese Spring and JSM1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. 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28600" indent="-228600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TaWRI1L1;</a:t>
            </a:r>
          </a:p>
          <a:p>
            <a:pPr marL="228600" indent="-228600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B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TaWRI1L2</a:t>
            </a:r>
          </a:p>
        </p:txBody>
      </p:sp>
      <p:sp>
        <p:nvSpPr>
          <p:cNvPr id="8" name="矩形 7"/>
          <p:cNvSpPr/>
          <p:nvPr/>
        </p:nvSpPr>
        <p:spPr>
          <a:xfrm>
            <a:off x="37084" y="293510"/>
            <a:ext cx="47970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b="1" dirty="0">
                <a:solidFill>
                  <a:srgbClr val="FF0000"/>
                </a:solidFill>
              </a:rPr>
              <a:t>A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  <p:sp>
        <p:nvSpPr>
          <p:cNvPr id="9" name="矩形 8"/>
          <p:cNvSpPr/>
          <p:nvPr/>
        </p:nvSpPr>
        <p:spPr>
          <a:xfrm>
            <a:off x="5521256" y="300692"/>
            <a:ext cx="47970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solidFill>
                  <a:srgbClr val="FF0000"/>
                </a:solidFill>
              </a:rPr>
              <a:t>B</a:t>
            </a:r>
            <a:endParaRPr lang="zh-CN" altLang="en-US" b="1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681135" y="264138"/>
            <a:ext cx="11094098" cy="5429481"/>
            <a:chOff x="1241615" y="470050"/>
            <a:chExt cx="10626952" cy="5333661"/>
          </a:xfrm>
        </p:grpSpPr>
        <p:graphicFrame>
          <p:nvGraphicFramePr>
            <p:cNvPr id="4" name="图表 3"/>
            <p:cNvGraphicFramePr/>
            <p:nvPr/>
          </p:nvGraphicFramePr>
          <p:xfrm>
            <a:off x="7235176" y="470050"/>
            <a:ext cx="4592542" cy="26479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6" name="图表 5"/>
            <p:cNvGraphicFramePr/>
            <p:nvPr/>
          </p:nvGraphicFramePr>
          <p:xfrm>
            <a:off x="7296567" y="3060511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pic>
          <p:nvPicPr>
            <p:cNvPr id="7" name="Picture 2" descr="http://bar.utoronto.ca/efp_wheat/cgi-bin/output/efp-0fb9PI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2778"/>
            <a:stretch/>
          </p:blipFill>
          <p:spPr bwMode="auto">
            <a:xfrm>
              <a:off x="1241615" y="3284419"/>
              <a:ext cx="3558986" cy="219735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" name="Picture 2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9651"/>
            <a:stretch/>
          </p:blipFill>
          <p:spPr bwMode="auto">
            <a:xfrm>
              <a:off x="4800601" y="3284418"/>
              <a:ext cx="2495966" cy="227615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9" name="Picture 3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9103"/>
            <a:stretch/>
          </p:blipFill>
          <p:spPr bwMode="auto">
            <a:xfrm>
              <a:off x="4803555" y="573760"/>
              <a:ext cx="2394688" cy="233142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" name="Picture 3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3250"/>
            <a:stretch/>
          </p:blipFill>
          <p:spPr bwMode="auto">
            <a:xfrm>
              <a:off x="1303006" y="597801"/>
              <a:ext cx="3436204" cy="218918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3" name="文本框 2"/>
          <p:cNvSpPr txBox="1"/>
          <p:nvPr/>
        </p:nvSpPr>
        <p:spPr>
          <a:xfrm>
            <a:off x="564385" y="264138"/>
            <a:ext cx="361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11" name="文本框 10"/>
          <p:cNvSpPr txBox="1"/>
          <p:nvPr/>
        </p:nvSpPr>
        <p:spPr>
          <a:xfrm>
            <a:off x="4331107" y="237980"/>
            <a:ext cx="361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  <p:sp>
        <p:nvSpPr>
          <p:cNvPr id="12" name="文本框 11"/>
          <p:cNvSpPr txBox="1"/>
          <p:nvPr/>
        </p:nvSpPr>
        <p:spPr>
          <a:xfrm>
            <a:off x="7221859" y="279396"/>
            <a:ext cx="361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13" name="文本框 12"/>
          <p:cNvSpPr txBox="1"/>
          <p:nvPr/>
        </p:nvSpPr>
        <p:spPr>
          <a:xfrm>
            <a:off x="500295" y="2875885"/>
            <a:ext cx="361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D</a:t>
            </a:r>
            <a:endParaRPr lang="zh-CN" altLang="en-US" dirty="0"/>
          </a:p>
        </p:txBody>
      </p:sp>
      <p:sp>
        <p:nvSpPr>
          <p:cNvPr id="14" name="文本框 13"/>
          <p:cNvSpPr txBox="1"/>
          <p:nvPr/>
        </p:nvSpPr>
        <p:spPr>
          <a:xfrm>
            <a:off x="4329734" y="2927685"/>
            <a:ext cx="361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E</a:t>
            </a:r>
            <a:endParaRPr lang="zh-CN" altLang="en-US" dirty="0"/>
          </a:p>
        </p:txBody>
      </p:sp>
      <p:sp>
        <p:nvSpPr>
          <p:cNvPr id="15" name="文本框 14"/>
          <p:cNvSpPr txBox="1"/>
          <p:nvPr/>
        </p:nvSpPr>
        <p:spPr>
          <a:xfrm>
            <a:off x="7221859" y="2927685"/>
            <a:ext cx="361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E4F7A2AD-1700-4E6E-9C67-964DB7487846}"/>
              </a:ext>
            </a:extLst>
          </p:cNvPr>
          <p:cNvSpPr txBox="1"/>
          <p:nvPr/>
        </p:nvSpPr>
        <p:spPr>
          <a:xfrm>
            <a:off x="681135" y="5487494"/>
            <a:ext cx="10916920" cy="138499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igure S2. The expression profiles of wheat </a:t>
            </a:r>
            <a:r>
              <a:rPr lang="en-US" altLang="zh-CN" sz="1200" b="1" i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TaWRI1L1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and </a:t>
            </a:r>
            <a:r>
              <a:rPr lang="en-US" altLang="zh-CN" sz="1200" b="1" i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TaWRI1L2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(data from Wheat </a:t>
            </a:r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eFP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). </a:t>
            </a:r>
            <a:endParaRPr lang="en-US" altLang="zh-C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342900" indent="-342900">
              <a:buAutoNum type="alphaUcPeriod"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Developmental expression profile of TaWRI1L1(TraesCS5B02G220400), </a:t>
            </a:r>
          </a:p>
          <a:p>
            <a:pPr marL="228600" indent="-228600">
              <a:buAutoNum type="alphaUcPeriod"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Embryogenesis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expression profile of TaWRI1L1(TraesCS5B02G220400,</a:t>
            </a:r>
          </a:p>
          <a:p>
            <a:pPr marL="228600" indent="-228600">
              <a:buAutoNum type="alphaUcPeriod"/>
            </a:pP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Expression level of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aWRI1L1(TraesCS5B02G220400), 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  <a:p>
            <a:pPr marL="228600" indent="-228600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D.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Developmental expression profile of TaWRI1L2 (TraesCS5A02G141700),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  <a:p>
            <a:pPr marL="228600" indent="-228600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E  Embryogenesis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expression profile of TaWRI1L2 (TraesCS5A02G141700),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  <a:p>
            <a:pPr marL="228600" indent="-228600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. Expression level of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TaWRI1L2 (TraesCS5A02G141700).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TPM: Transcripts per million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6</TotalTime>
  <Words>107</Words>
  <Application>Microsoft Office PowerPoint</Application>
  <PresentationFormat>Widescreen</PresentationFormat>
  <Paragraphs>2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p</dc:creator>
  <cp:lastModifiedBy>MDPI</cp:lastModifiedBy>
  <cp:revision>156</cp:revision>
  <dcterms:created xsi:type="dcterms:W3CDTF">2021-11-04T07:45:00Z</dcterms:created>
  <dcterms:modified xsi:type="dcterms:W3CDTF">2022-05-10T06:32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158E947B5FB7495EAA4EED1BA76182C9</vt:lpwstr>
  </property>
  <property fmtid="{D5CDD505-2E9C-101B-9397-08002B2CF9AE}" pid="3" name="KSOProductBuildVer">
    <vt:lpwstr>2052-11.1.0.11294</vt:lpwstr>
  </property>
</Properties>
</file>